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4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ina Lin" initials="TL" lastIdx="2" clrIdx="0">
    <p:extLst>
      <p:ext uri="{19B8F6BF-5375-455C-9EA6-DF929625EA0E}">
        <p15:presenceInfo xmlns:p15="http://schemas.microsoft.com/office/powerpoint/2012/main" userId="94724a9251d6059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FFFF"/>
    <a:srgbClr val="CCFFFF"/>
    <a:srgbClr val="FFCCFF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16" autoAdjust="0"/>
    <p:restoredTop sz="93807" autoAdjust="0"/>
  </p:normalViewPr>
  <p:slideViewPr>
    <p:cSldViewPr snapToGrid="0">
      <p:cViewPr varScale="1">
        <p:scale>
          <a:sx n="71" d="100"/>
          <a:sy n="71" d="100"/>
        </p:scale>
        <p:origin x="343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1" d="100"/>
          <a:sy n="51" d="100"/>
        </p:scale>
        <p:origin x="2692" y="5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>
            <a:extLst>
              <a:ext uri="{FF2B5EF4-FFF2-40B4-BE49-F238E27FC236}">
                <a16:creationId xmlns:a16="http://schemas.microsoft.com/office/drawing/2014/main" id="{89B20316-F1F4-4390-885E-BFA9EFB99C64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E444339A-4781-4BD1-8872-F2D5525B38B1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07786E-2773-4467-9FBF-C32A366E9DC0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D1578D52-DA32-4805-A54F-7AAF1231C664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78DC0805-2224-426C-A888-AF2AC4CD37C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457366-EFD7-4FBD-92DC-FB9C0DD8385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757828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19C51F-6083-456D-9E6B-226D12625595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5CEF66-501E-4273-B060-ACF9C9C0F4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3622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43594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59111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6788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13473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6145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55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40610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745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9097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6986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4630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89230-2A9F-4D2F-8454-175C87899219}" type="datetimeFigureOut">
              <a:rPr lang="zh-TW" altLang="en-US" smtClean="0"/>
              <a:t>2022/10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E63A8-D234-47E0-897B-F693964F12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52023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3AF9CDE-4C0E-97D6-6BA6-2649F860E42C}"/>
              </a:ext>
            </a:extLst>
          </p:cNvPr>
          <p:cNvSpPr txBox="1"/>
          <p:nvPr/>
        </p:nvSpPr>
        <p:spPr>
          <a:xfrm>
            <a:off x="304800" y="986118"/>
            <a:ext cx="64285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1. The densitometry intensity ratio of each band for the Western blot.</a:t>
            </a:r>
          </a:p>
        </p:txBody>
      </p:sp>
      <p:pic>
        <p:nvPicPr>
          <p:cNvPr id="5" name="圖片 3">
            <a:extLst>
              <a:ext uri="{FF2B5EF4-FFF2-40B4-BE49-F238E27FC236}">
                <a16:creationId xmlns:a16="http://schemas.microsoft.com/office/drawing/2014/main" id="{B7802007-AAA8-1CE0-AE79-2BF896B68D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524" t="37911" r="72368" b="15792"/>
          <a:stretch/>
        </p:blipFill>
        <p:spPr>
          <a:xfrm>
            <a:off x="927188" y="2147914"/>
            <a:ext cx="1112109" cy="1175727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888E84CB-8B17-8B6D-E9B4-B58E5D71F5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8744552"/>
              </p:ext>
            </p:extLst>
          </p:nvPr>
        </p:nvGraphicFramePr>
        <p:xfrm>
          <a:off x="2437707" y="2355695"/>
          <a:ext cx="2927454" cy="8695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75818">
                  <a:extLst>
                    <a:ext uri="{9D8B030D-6E8A-4147-A177-3AD203B41FA5}">
                      <a16:colId xmlns:a16="http://schemas.microsoft.com/office/drawing/2014/main" val="3714964931"/>
                    </a:ext>
                  </a:extLst>
                </a:gridCol>
                <a:gridCol w="975818">
                  <a:extLst>
                    <a:ext uri="{9D8B030D-6E8A-4147-A177-3AD203B41FA5}">
                      <a16:colId xmlns:a16="http://schemas.microsoft.com/office/drawing/2014/main" val="14474713"/>
                    </a:ext>
                  </a:extLst>
                </a:gridCol>
                <a:gridCol w="975818">
                  <a:extLst>
                    <a:ext uri="{9D8B030D-6E8A-4147-A177-3AD203B41FA5}">
                      <a16:colId xmlns:a16="http://schemas.microsoft.com/office/drawing/2014/main" val="2714299683"/>
                    </a:ext>
                  </a:extLst>
                </a:gridCol>
              </a:tblGrid>
              <a:tr h="289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 1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nsi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27447067"/>
                  </a:ext>
                </a:extLst>
              </a:tr>
              <a:tr h="289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t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00.8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61855927"/>
                  </a:ext>
                </a:extLst>
              </a:tr>
              <a:tr h="289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t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61.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12924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95507242"/>
                  </a:ext>
                </a:extLst>
              </a:tr>
            </a:tbl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E7D0D090-3C93-54B1-F738-A335810F1B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4250417"/>
              </p:ext>
            </p:extLst>
          </p:nvPr>
        </p:nvGraphicFramePr>
        <p:xfrm>
          <a:off x="2437707" y="4496689"/>
          <a:ext cx="2927453" cy="8695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84377">
                  <a:extLst>
                    <a:ext uri="{9D8B030D-6E8A-4147-A177-3AD203B41FA5}">
                      <a16:colId xmlns:a16="http://schemas.microsoft.com/office/drawing/2014/main" val="2519080161"/>
                    </a:ext>
                  </a:extLst>
                </a:gridCol>
                <a:gridCol w="821538">
                  <a:extLst>
                    <a:ext uri="{9D8B030D-6E8A-4147-A177-3AD203B41FA5}">
                      <a16:colId xmlns:a16="http://schemas.microsoft.com/office/drawing/2014/main" val="1839593402"/>
                    </a:ext>
                  </a:extLst>
                </a:gridCol>
                <a:gridCol w="821538">
                  <a:extLst>
                    <a:ext uri="{9D8B030D-6E8A-4147-A177-3AD203B41FA5}">
                      <a16:colId xmlns:a16="http://schemas.microsoft.com/office/drawing/2014/main" val="3247559676"/>
                    </a:ext>
                  </a:extLst>
                </a:gridCol>
              </a:tblGrid>
              <a:tr h="289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 5 (a) (b)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76391345"/>
                  </a:ext>
                </a:extLst>
              </a:tr>
              <a:tr h="289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t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555.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79909147"/>
                  </a:ext>
                </a:extLst>
              </a:tr>
              <a:tr h="2898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t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639.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1924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1220416"/>
                  </a:ext>
                </a:extLst>
              </a:tr>
            </a:tbl>
          </a:graphicData>
        </a:graphic>
      </p:graphicFrame>
      <p:pic>
        <p:nvPicPr>
          <p:cNvPr id="19" name="圖片 2">
            <a:extLst>
              <a:ext uri="{FF2B5EF4-FFF2-40B4-BE49-F238E27FC236}">
                <a16:creationId xmlns:a16="http://schemas.microsoft.com/office/drawing/2014/main" id="{7C9DC823-4A95-8ADD-1A64-266FD3CF72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700" t="35180" r="66193" b="-5356"/>
          <a:stretch/>
        </p:blipFill>
        <p:spPr>
          <a:xfrm>
            <a:off x="793967" y="4107112"/>
            <a:ext cx="1352992" cy="1609324"/>
          </a:xfrm>
          <a:prstGeom prst="rect">
            <a:avLst/>
          </a:prstGeom>
        </p:spPr>
      </p:pic>
      <p:pic>
        <p:nvPicPr>
          <p:cNvPr id="20" name="圖片 4">
            <a:extLst>
              <a:ext uri="{FF2B5EF4-FFF2-40B4-BE49-F238E27FC236}">
                <a16:creationId xmlns:a16="http://schemas.microsoft.com/office/drawing/2014/main" id="{AAB978D7-9C6F-7B86-813C-35161C4077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363" t="32794" r="50000" b="-1585"/>
          <a:stretch/>
        </p:blipFill>
        <p:spPr>
          <a:xfrm>
            <a:off x="927188" y="6199750"/>
            <a:ext cx="1225916" cy="1356154"/>
          </a:xfrm>
          <a:prstGeom prst="rect">
            <a:avLst/>
          </a:prstGeom>
        </p:spPr>
      </p:pic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948F7ABF-82ED-53D1-1B1E-49E9877644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9596146"/>
              </p:ext>
            </p:extLst>
          </p:nvPr>
        </p:nvGraphicFramePr>
        <p:xfrm>
          <a:off x="2437707" y="6680726"/>
          <a:ext cx="2927453" cy="77507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84377">
                  <a:extLst>
                    <a:ext uri="{9D8B030D-6E8A-4147-A177-3AD203B41FA5}">
                      <a16:colId xmlns:a16="http://schemas.microsoft.com/office/drawing/2014/main" val="138939920"/>
                    </a:ext>
                  </a:extLst>
                </a:gridCol>
                <a:gridCol w="821538">
                  <a:extLst>
                    <a:ext uri="{9D8B030D-6E8A-4147-A177-3AD203B41FA5}">
                      <a16:colId xmlns:a16="http://schemas.microsoft.com/office/drawing/2014/main" val="183860975"/>
                    </a:ext>
                  </a:extLst>
                </a:gridCol>
                <a:gridCol w="821538">
                  <a:extLst>
                    <a:ext uri="{9D8B030D-6E8A-4147-A177-3AD203B41FA5}">
                      <a16:colId xmlns:a16="http://schemas.microsoft.com/office/drawing/2014/main" val="3578447536"/>
                    </a:ext>
                  </a:extLst>
                </a:gridCol>
              </a:tblGrid>
              <a:tr h="2583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 5 (b) (c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</a:t>
                      </a:r>
                      <a:endParaRPr lang="en-US" sz="1200" b="0" i="0" u="none" strike="noStrike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0053407"/>
                  </a:ext>
                </a:extLst>
              </a:tr>
              <a:tr h="2583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t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47.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92596390"/>
                  </a:ext>
                </a:extLst>
              </a:tr>
              <a:tr h="2583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t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928.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4872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47616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23113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37</TotalTime>
  <Words>63</Words>
  <Application>Microsoft Macintosh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Tina Lin</dc:creator>
  <cp:lastModifiedBy>Winni Chen</cp:lastModifiedBy>
  <cp:revision>254</cp:revision>
  <cp:lastPrinted>2021-03-25T07:41:50Z</cp:lastPrinted>
  <dcterms:created xsi:type="dcterms:W3CDTF">2021-03-18T09:23:22Z</dcterms:created>
  <dcterms:modified xsi:type="dcterms:W3CDTF">2022-10-29T14:55:16Z</dcterms:modified>
</cp:coreProperties>
</file>